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0" r:id="rId3"/>
    <p:sldId id="259" r:id="rId4"/>
    <p:sldId id="258" r:id="rId5"/>
    <p:sldId id="257" r:id="rId6"/>
    <p:sldId id="256" r:id="rId7"/>
  </p:sldIdLst>
  <p:sldSz cx="12192000" cy="6858000"/>
  <p:notesSz cx="6807200" cy="99393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643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ina Zec" userId="2ab064d0-83a2-4d17-8795-9b147c78d974" providerId="ADAL" clId="{C50DD880-D217-4E1E-B8A1-2A1E4E1F3350}"/>
    <pc:docChg chg="modSld">
      <pc:chgData name="Nina Zec" userId="2ab064d0-83a2-4d17-8795-9b147c78d974" providerId="ADAL" clId="{C50DD880-D217-4E1E-B8A1-2A1E4E1F3350}" dt="2024-04-04T13:33:35.004" v="18" actId="113"/>
      <pc:docMkLst>
        <pc:docMk/>
      </pc:docMkLst>
      <pc:sldChg chg="modSp mod">
        <pc:chgData name="Nina Zec" userId="2ab064d0-83a2-4d17-8795-9b147c78d974" providerId="ADAL" clId="{C50DD880-D217-4E1E-B8A1-2A1E4E1F3350}" dt="2024-04-04T13:33:35.004" v="18" actId="113"/>
        <pc:sldMkLst>
          <pc:docMk/>
          <pc:sldMk cId="3293738499" sldId="256"/>
        </pc:sldMkLst>
        <pc:spChg chg="mod">
          <ac:chgData name="Nina Zec" userId="2ab064d0-83a2-4d17-8795-9b147c78d974" providerId="ADAL" clId="{C50DD880-D217-4E1E-B8A1-2A1E4E1F3350}" dt="2024-04-04T13:33:35.004" v="18" actId="113"/>
          <ac:spMkLst>
            <pc:docMk/>
            <pc:sldMk cId="3293738499" sldId="256"/>
            <ac:spMk id="7" creationId="{D670CFC9-97D1-4094-9599-DB0ABDCF512C}"/>
          </ac:spMkLst>
        </pc:spChg>
      </pc:sldChg>
      <pc:sldChg chg="modSp mod">
        <pc:chgData name="Nina Zec" userId="2ab064d0-83a2-4d17-8795-9b147c78d974" providerId="ADAL" clId="{C50DD880-D217-4E1E-B8A1-2A1E4E1F3350}" dt="2024-04-04T13:33:28.903" v="15" actId="113"/>
        <pc:sldMkLst>
          <pc:docMk/>
          <pc:sldMk cId="92584706" sldId="257"/>
        </pc:sldMkLst>
        <pc:spChg chg="mod">
          <ac:chgData name="Nina Zec" userId="2ab064d0-83a2-4d17-8795-9b147c78d974" providerId="ADAL" clId="{C50DD880-D217-4E1E-B8A1-2A1E4E1F3350}" dt="2024-04-04T13:33:28.903" v="15" actId="113"/>
          <ac:spMkLst>
            <pc:docMk/>
            <pc:sldMk cId="92584706" sldId="257"/>
            <ac:spMk id="6" creationId="{D670CFC9-97D1-4094-9599-DB0ABDCF512C}"/>
          </ac:spMkLst>
        </pc:spChg>
      </pc:sldChg>
      <pc:sldChg chg="modSp mod">
        <pc:chgData name="Nina Zec" userId="2ab064d0-83a2-4d17-8795-9b147c78d974" providerId="ADAL" clId="{C50DD880-D217-4E1E-B8A1-2A1E4E1F3350}" dt="2024-04-04T13:33:22.371" v="12" actId="113"/>
        <pc:sldMkLst>
          <pc:docMk/>
          <pc:sldMk cId="853824544" sldId="258"/>
        </pc:sldMkLst>
        <pc:spChg chg="mod">
          <ac:chgData name="Nina Zec" userId="2ab064d0-83a2-4d17-8795-9b147c78d974" providerId="ADAL" clId="{C50DD880-D217-4E1E-B8A1-2A1E4E1F3350}" dt="2024-04-04T13:33:22.371" v="12" actId="113"/>
          <ac:spMkLst>
            <pc:docMk/>
            <pc:sldMk cId="853824544" sldId="258"/>
            <ac:spMk id="8" creationId="{D670CFC9-97D1-4094-9599-DB0ABDCF512C}"/>
          </ac:spMkLst>
        </pc:spChg>
      </pc:sldChg>
      <pc:sldChg chg="modSp mod">
        <pc:chgData name="Nina Zec" userId="2ab064d0-83a2-4d17-8795-9b147c78d974" providerId="ADAL" clId="{C50DD880-D217-4E1E-B8A1-2A1E4E1F3350}" dt="2024-04-04T13:33:16.091" v="9" actId="113"/>
        <pc:sldMkLst>
          <pc:docMk/>
          <pc:sldMk cId="1514584540" sldId="259"/>
        </pc:sldMkLst>
        <pc:spChg chg="mod">
          <ac:chgData name="Nina Zec" userId="2ab064d0-83a2-4d17-8795-9b147c78d974" providerId="ADAL" clId="{C50DD880-D217-4E1E-B8A1-2A1E4E1F3350}" dt="2024-04-04T13:33:16.091" v="9" actId="113"/>
          <ac:spMkLst>
            <pc:docMk/>
            <pc:sldMk cId="1514584540" sldId="259"/>
            <ac:spMk id="8" creationId="{D670CFC9-97D1-4094-9599-DB0ABDCF512C}"/>
          </ac:spMkLst>
        </pc:spChg>
      </pc:sldChg>
      <pc:sldChg chg="modSp mod">
        <pc:chgData name="Nina Zec" userId="2ab064d0-83a2-4d17-8795-9b147c78d974" providerId="ADAL" clId="{C50DD880-D217-4E1E-B8A1-2A1E4E1F3350}" dt="2024-04-04T13:33:08.219" v="6" actId="113"/>
        <pc:sldMkLst>
          <pc:docMk/>
          <pc:sldMk cId="3201120607" sldId="260"/>
        </pc:sldMkLst>
        <pc:spChg chg="mod">
          <ac:chgData name="Nina Zec" userId="2ab064d0-83a2-4d17-8795-9b147c78d974" providerId="ADAL" clId="{C50DD880-D217-4E1E-B8A1-2A1E4E1F3350}" dt="2024-04-04T13:33:08.219" v="6" actId="113"/>
          <ac:spMkLst>
            <pc:docMk/>
            <pc:sldMk cId="3201120607" sldId="260"/>
            <ac:spMk id="7" creationId="{D670CFC9-97D1-4094-9599-DB0ABDCF512C}"/>
          </ac:spMkLst>
        </pc:spChg>
      </pc:sldChg>
      <pc:sldChg chg="modSp mod">
        <pc:chgData name="Nina Zec" userId="2ab064d0-83a2-4d17-8795-9b147c78d974" providerId="ADAL" clId="{C50DD880-D217-4E1E-B8A1-2A1E4E1F3350}" dt="2024-04-04T13:32:59.715" v="2" actId="113"/>
        <pc:sldMkLst>
          <pc:docMk/>
          <pc:sldMk cId="624876409" sldId="261"/>
        </pc:sldMkLst>
        <pc:spChg chg="mod">
          <ac:chgData name="Nina Zec" userId="2ab064d0-83a2-4d17-8795-9b147c78d974" providerId="ADAL" clId="{C50DD880-D217-4E1E-B8A1-2A1E4E1F3350}" dt="2024-04-04T13:32:59.715" v="2" actId="113"/>
          <ac:spMkLst>
            <pc:docMk/>
            <pc:sldMk cId="624876409" sldId="261"/>
            <ac:spMk id="8" creationId="{D670CFC9-97D1-4094-9599-DB0ABDCF512C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F9ED313-A3F3-48D2-BD77-102BD98ECE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F10C2D9B-07C8-4BB9-B2E5-CB4FA5FFDC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A79A751-4B0B-423A-AFD5-1836AF9DB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BFD8-2B9A-4782-80CA-4B135BB9B798}" type="datetimeFigureOut">
              <a:rPr lang="ko-KR" altLang="en-US" smtClean="0"/>
              <a:t>2024-04-04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8C59174-F1B4-4A0E-ACA6-223F5AAD8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9605249-D88C-4C89-A61E-AEFEC85EDF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710F3-56FF-47D9-AF69-07448E5F66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339826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9AC7B6A-8E50-4E98-AE20-B08E1AD942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158AAA97-521F-46A6-8901-E1DCF1D2209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FB43312-7064-4BC5-AA86-7F2D86C58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BFD8-2B9A-4782-80CA-4B135BB9B798}" type="datetimeFigureOut">
              <a:rPr lang="ko-KR" altLang="en-US" smtClean="0"/>
              <a:t>2024-04-04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483F53C-AB21-47A7-92CE-B653887E0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3A88F8D-B7F7-4A06-8EA1-752AD4EFD9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710F3-56FF-47D9-AF69-07448E5F66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950008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7CFC0EE-E4D0-4AC8-A0F6-53E4FF7B88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8B4B020E-2929-4834-8543-8153F69927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9CA44AE-03A4-4CE7-A860-051ACDDC8B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BFD8-2B9A-4782-80CA-4B135BB9B798}" type="datetimeFigureOut">
              <a:rPr lang="ko-KR" altLang="en-US" smtClean="0"/>
              <a:t>2024-04-04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BD8131D-DBE5-4E8E-8BC5-7A81FE77D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F47C8E5-48B2-457A-8B7D-F295B97558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710F3-56FF-47D9-AF69-07448E5F66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70440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58DD2A2-2379-4F0B-9ADD-86A5869C71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E7D8968-C7BB-488F-A288-5E2EF78300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F2974C5-985E-4861-AE07-C2E760D60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BFD8-2B9A-4782-80CA-4B135BB9B798}" type="datetimeFigureOut">
              <a:rPr lang="ko-KR" altLang="en-US" smtClean="0"/>
              <a:t>2024-04-04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0DDD035-E75F-4F94-B166-41A369F67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4E5C097-1B69-4267-9347-AC78A33FB1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710F3-56FF-47D9-AF69-07448E5F66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24599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2835CA3-BC27-4255-AE84-293C22B0CE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4A34413-FBBA-4F7F-B9C8-8803A30E49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12B1594-7753-43E2-B449-271A913FF2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BFD8-2B9A-4782-80CA-4B135BB9B798}" type="datetimeFigureOut">
              <a:rPr lang="ko-KR" altLang="en-US" smtClean="0"/>
              <a:t>2024-04-04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CA6AEBD-F71A-4F41-B181-53E265BE01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05D7B1B-7D77-4C6C-B152-3E6FC6E315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710F3-56FF-47D9-AF69-07448E5F66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079075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728A101-42A1-4B8A-869C-97D5D6813B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8C4DDCAD-6F59-4BC4-ABAA-ED80420935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037056EA-F7BD-4DAD-B4B2-CE9A74613D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CBE941A-6BB4-4B12-94E9-A5329763F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BFD8-2B9A-4782-80CA-4B135BB9B798}" type="datetimeFigureOut">
              <a:rPr lang="ko-KR" altLang="en-US" smtClean="0"/>
              <a:t>2024-04-04</a:t>
            </a:fld>
            <a:endParaRPr lang="ko-KR" altLang="en-US" dirty="0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2B5045E-CB5A-49B1-95B1-385699A3B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334C39F-C556-4902-8F05-3F9981E6FD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710F3-56FF-47D9-AF69-07448E5F66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425610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CBD68C1-88BC-4AE5-A905-EA73CB10EC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79CD329-C85F-4D0C-81C9-C8DC2BF94E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10102B9-7B5A-4505-ABF7-5EFB7FAA9C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7AB7198A-0453-434B-9965-4A34AD4CF2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1E0B28E3-DB40-4855-9645-1C83EBCC47A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32763A4D-7EBA-4B15-851B-F78A34F0C2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BFD8-2B9A-4782-80CA-4B135BB9B798}" type="datetimeFigureOut">
              <a:rPr lang="ko-KR" altLang="en-US" smtClean="0"/>
              <a:t>2024-04-04</a:t>
            </a:fld>
            <a:endParaRPr lang="ko-KR" altLang="en-US" dirty="0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1F43BB69-7CD1-400A-BF4C-704237AAE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949FC75-C6B3-401D-867D-4D70F1F9B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710F3-56FF-47D9-AF69-07448E5F66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425928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BBA9363-03B2-4D72-A704-442B6B1430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BE2B0E72-B770-4709-A647-E751F62627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BFD8-2B9A-4782-80CA-4B135BB9B798}" type="datetimeFigureOut">
              <a:rPr lang="ko-KR" altLang="en-US" smtClean="0"/>
              <a:t>2024-04-04</a:t>
            </a:fld>
            <a:endParaRPr lang="ko-KR" altLang="en-US" dirty="0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54AF5D0-948D-4C6B-A189-E2FAD5755C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D9706210-E5B2-456E-BC2A-17850A01FC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710F3-56FF-47D9-AF69-07448E5F66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30338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A448BFC2-7733-47AA-A859-64FB23ED28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BFD8-2B9A-4782-80CA-4B135BB9B798}" type="datetimeFigureOut">
              <a:rPr lang="ko-KR" altLang="en-US" smtClean="0"/>
              <a:t>2024-04-04</a:t>
            </a:fld>
            <a:endParaRPr lang="ko-KR" altLang="en-US" dirty="0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FC7426EC-EBEB-4C4A-A143-77120A16D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C2DDC9C-242F-42ED-B292-CA63F5BD1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710F3-56FF-47D9-AF69-07448E5F66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05879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D42913-1338-4457-A48E-2862BED96D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0AEBE34-4F00-4230-8FA8-8981041C0D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F320DE36-5DB4-4B9D-927D-2DFDBD65A8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8735B1C-41C9-472E-86B7-147472F855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BFD8-2B9A-4782-80CA-4B135BB9B798}" type="datetimeFigureOut">
              <a:rPr lang="ko-KR" altLang="en-US" smtClean="0"/>
              <a:t>2024-04-04</a:t>
            </a:fld>
            <a:endParaRPr lang="ko-KR" altLang="en-US" dirty="0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1AC0AA6-D5A2-4B2A-92C6-5926AA006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EC883D8-91C6-4974-AEA8-2E56BB016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710F3-56FF-47D9-AF69-07448E5F66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484333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F87E840-2CF1-40D5-A032-EC7DD6F98D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B9AC1001-F86E-4D39-A905-BCBC0B8F05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 dirty="0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225947B-6C64-4E7C-BF9F-722EFDA273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026E538-DFB4-4F52-8FC1-3C280E53D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EEBFD8-2B9A-4782-80CA-4B135BB9B798}" type="datetimeFigureOut">
              <a:rPr lang="ko-KR" altLang="en-US" smtClean="0"/>
              <a:t>2024-04-04</a:t>
            </a:fld>
            <a:endParaRPr lang="ko-KR" altLang="en-US" dirty="0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6A503B1-AF7B-4AAC-A874-CDA8570878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B2E2B15-75F8-41DC-B4C1-47F6517DB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6710F3-56FF-47D9-AF69-07448E5F66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75946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E8FEEFF-5CF8-44DC-95E4-6C16342959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94D370F-BA88-477C-B4C1-EDDB5BD18A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37A992A-529A-41BC-AA0A-A17FD29B38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EBFD8-2B9A-4782-80CA-4B135BB9B798}" type="datetimeFigureOut">
              <a:rPr lang="ko-KR" altLang="en-US" smtClean="0"/>
              <a:t>2024-04-04</a:t>
            </a:fld>
            <a:endParaRPr lang="ko-KR" altLang="en-US" dirty="0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68DB9AC-9498-46CA-8E5D-91430D989F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770FBFA-0934-4CA4-9F77-BB2D4FE2EE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6710F3-56FF-47D9-AF69-07448E5F66B4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600502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5238D1D0-85C5-4E2E-A1ED-833B75339A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17519" y="536894"/>
            <a:ext cx="6668005" cy="615913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F636D39-AC15-4CC7-B9A0-CB123A414209}"/>
              </a:ext>
            </a:extLst>
          </p:cNvPr>
          <p:cNvSpPr txBox="1"/>
          <p:nvPr/>
        </p:nvSpPr>
        <p:spPr>
          <a:xfrm>
            <a:off x="7276423" y="3430900"/>
            <a:ext cx="1290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2019-22 KOREA</a:t>
            </a:r>
            <a:endParaRPr lang="ko-KR" altLang="en-US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F096AA8-7BC0-4FF9-B143-C23AF519660A}"/>
              </a:ext>
            </a:extLst>
          </p:cNvPr>
          <p:cNvSpPr txBox="1"/>
          <p:nvPr/>
        </p:nvSpPr>
        <p:spPr>
          <a:xfrm>
            <a:off x="7276423" y="855595"/>
            <a:ext cx="1290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2018-19 KOREA</a:t>
            </a:r>
            <a:endParaRPr lang="ko-KR" altLang="en-US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670CFC9-97D1-4094-9599-DB0ABDCF512C}"/>
              </a:ext>
            </a:extLst>
          </p:cNvPr>
          <p:cNvSpPr txBox="1"/>
          <p:nvPr/>
        </p:nvSpPr>
        <p:spPr>
          <a:xfrm>
            <a:off x="250827" y="98313"/>
            <a:ext cx="9638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Figure S1(a) </a:t>
            </a:r>
            <a:r>
              <a:rPr lang="en-US" altLang="ko-KR" dirty="0"/>
              <a:t>Maximum-likelihood tree of PB2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62487640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142D2FA9-E1A4-444F-8D50-646BEF4FFD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9920" y="499382"/>
            <a:ext cx="6350938" cy="635861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D9E4E32-9613-4294-BCB0-1170C8EC1796}"/>
              </a:ext>
            </a:extLst>
          </p:cNvPr>
          <p:cNvSpPr txBox="1"/>
          <p:nvPr/>
        </p:nvSpPr>
        <p:spPr>
          <a:xfrm>
            <a:off x="7284812" y="3587506"/>
            <a:ext cx="1290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2019-22 KOREA</a:t>
            </a:r>
            <a:endParaRPr lang="ko-KR" altLang="en-US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670CFC9-97D1-4094-9599-DB0ABDCF512C}"/>
              </a:ext>
            </a:extLst>
          </p:cNvPr>
          <p:cNvSpPr txBox="1"/>
          <p:nvPr/>
        </p:nvSpPr>
        <p:spPr>
          <a:xfrm>
            <a:off x="250827" y="98313"/>
            <a:ext cx="9638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Figure S1(b) </a:t>
            </a:r>
            <a:r>
              <a:rPr lang="en-US" altLang="ko-KR" dirty="0"/>
              <a:t>Maximum-likelihood tree of PB1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011206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BB1F66E5-4176-4FF7-B674-150883F973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9920" y="471624"/>
            <a:ext cx="6318794" cy="638637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498DCC4-B4AE-41EA-8F36-0B91F90BF6B9}"/>
              </a:ext>
            </a:extLst>
          </p:cNvPr>
          <p:cNvSpPr txBox="1"/>
          <p:nvPr/>
        </p:nvSpPr>
        <p:spPr>
          <a:xfrm>
            <a:off x="7179298" y="1035628"/>
            <a:ext cx="1290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2021-22 KOREA</a:t>
            </a:r>
            <a:endParaRPr lang="ko-KR" altLang="en-US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102A7A9-465A-44CB-855B-7D317AF169AC}"/>
              </a:ext>
            </a:extLst>
          </p:cNvPr>
          <p:cNvSpPr txBox="1"/>
          <p:nvPr/>
        </p:nvSpPr>
        <p:spPr>
          <a:xfrm>
            <a:off x="7189458" y="3465351"/>
            <a:ext cx="20301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H5N8 HPAI in Korea, 2021</a:t>
            </a:r>
            <a:endParaRPr lang="ko-KR" altLang="en-US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670CFC9-97D1-4094-9599-DB0ABDCF512C}"/>
              </a:ext>
            </a:extLst>
          </p:cNvPr>
          <p:cNvSpPr txBox="1"/>
          <p:nvPr/>
        </p:nvSpPr>
        <p:spPr>
          <a:xfrm>
            <a:off x="250827" y="98313"/>
            <a:ext cx="9638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Figure S1(c) </a:t>
            </a:r>
            <a:r>
              <a:rPr lang="en-US" altLang="ko-KR" dirty="0"/>
              <a:t>Maximum-likelihood tree of P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145845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687F886A-84A2-4E5C-A316-0BE00797E4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3280" y="505382"/>
            <a:ext cx="5837356" cy="629117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3A1CB66-FDD7-42E3-BB85-C57BC9037575}"/>
              </a:ext>
            </a:extLst>
          </p:cNvPr>
          <p:cNvSpPr txBox="1"/>
          <p:nvPr/>
        </p:nvSpPr>
        <p:spPr>
          <a:xfrm>
            <a:off x="6970878" y="3190147"/>
            <a:ext cx="1290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2021-22 KOREA</a:t>
            </a:r>
            <a:endParaRPr lang="ko-KR" altLang="en-US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31087F0-1161-4318-A12C-8A1E94D1010A}"/>
              </a:ext>
            </a:extLst>
          </p:cNvPr>
          <p:cNvSpPr txBox="1"/>
          <p:nvPr/>
        </p:nvSpPr>
        <p:spPr>
          <a:xfrm>
            <a:off x="6991198" y="5508585"/>
            <a:ext cx="10582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2020 KOREA</a:t>
            </a:r>
            <a:endParaRPr lang="ko-KR" altLang="en-US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670CFC9-97D1-4094-9599-DB0ABDCF512C}"/>
              </a:ext>
            </a:extLst>
          </p:cNvPr>
          <p:cNvSpPr txBox="1"/>
          <p:nvPr/>
        </p:nvSpPr>
        <p:spPr>
          <a:xfrm>
            <a:off x="250827" y="98313"/>
            <a:ext cx="9638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Figure S1(d) </a:t>
            </a:r>
            <a:r>
              <a:rPr lang="en-US" altLang="ko-KR" dirty="0"/>
              <a:t>Maximum-likelihood tree of NP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8538245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4B89256F-04A6-4B40-83C3-238499781B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80079" y="485682"/>
            <a:ext cx="6313001" cy="637231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670CFC9-97D1-4094-9599-DB0ABDCF512C}"/>
              </a:ext>
            </a:extLst>
          </p:cNvPr>
          <p:cNvSpPr txBox="1"/>
          <p:nvPr/>
        </p:nvSpPr>
        <p:spPr>
          <a:xfrm>
            <a:off x="250827" y="98313"/>
            <a:ext cx="9638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Figure S1(e) </a:t>
            </a:r>
            <a:r>
              <a:rPr lang="en-US" altLang="ko-KR" dirty="0"/>
              <a:t>Maximum-likelihood tree of MP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25847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FF752F05-D9E3-4EEA-B2C5-220AA0F59B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9280" y="500858"/>
            <a:ext cx="6440897" cy="635714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9C31D9F-A3AC-47EC-9BDA-97B42910BFDC}"/>
              </a:ext>
            </a:extLst>
          </p:cNvPr>
          <p:cNvSpPr txBox="1"/>
          <p:nvPr/>
        </p:nvSpPr>
        <p:spPr>
          <a:xfrm>
            <a:off x="7266730" y="6478508"/>
            <a:ext cx="1290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2020-22 KOREA</a:t>
            </a:r>
            <a:endParaRPr lang="ko-KR" altLang="en-US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670CFC9-97D1-4094-9599-DB0ABDCF512C}"/>
              </a:ext>
            </a:extLst>
          </p:cNvPr>
          <p:cNvSpPr txBox="1"/>
          <p:nvPr/>
        </p:nvSpPr>
        <p:spPr>
          <a:xfrm>
            <a:off x="250827" y="98313"/>
            <a:ext cx="9638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Figure S1(f) </a:t>
            </a:r>
            <a:r>
              <a:rPr lang="en-US" altLang="ko-KR" dirty="0"/>
              <a:t>Maximum-likelihood tree of N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937384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5</TotalTime>
  <Words>74</Words>
  <Application>Microsoft Office PowerPoint</Application>
  <PresentationFormat>Widescreen</PresentationFormat>
  <Paragraphs>1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9" baseType="lpstr">
      <vt:lpstr>맑은 고딕</vt:lpstr>
      <vt:lpstr>Arial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DPI</cp:lastModifiedBy>
  <cp:revision>11</cp:revision>
  <cp:lastPrinted>2024-03-09T02:57:17Z</cp:lastPrinted>
  <dcterms:created xsi:type="dcterms:W3CDTF">2024-03-08T23:08:37Z</dcterms:created>
  <dcterms:modified xsi:type="dcterms:W3CDTF">2024-04-04T13:33:36Z</dcterms:modified>
</cp:coreProperties>
</file>